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29" autoAdjust="0"/>
    <p:restoredTop sz="94660"/>
  </p:normalViewPr>
  <p:slideViewPr>
    <p:cSldViewPr snapToGrid="0">
      <p:cViewPr varScale="1">
        <p:scale>
          <a:sx n="96" d="100"/>
          <a:sy n="96" d="100"/>
        </p:scale>
        <p:origin x="12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r>
              <a:rPr lang="en-US" sz="1600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REF6</a:t>
            </a:r>
            <a:endParaRPr lang="zh-CN" sz="1600" i="1" dirty="0">
              <a:latin typeface="Calibri Light" panose="020F0302020204030204" pitchFamily="34" charset="0"/>
              <a:cs typeface="Calibri Light" panose="020F0302020204030204" pitchFamily="34" charset="0"/>
            </a:endParaRPr>
          </a:p>
        </c:rich>
      </c:tx>
      <c:layout>
        <c:manualLayout>
          <c:xMode val="edge"/>
          <c:yMode val="edge"/>
          <c:x val="0.5035763342082239"/>
          <c:y val="4.25489583623264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j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014031058617673"/>
          <c:y val="0.10522736245939679"/>
          <c:w val="0.7680413385826772"/>
          <c:h val="0.557435681747192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C$18:$C$28</c:f>
                <c:numCache>
                  <c:formatCode>General</c:formatCode>
                  <c:ptCount val="11"/>
                  <c:pt idx="0">
                    <c:v>0.19686125758543227</c:v>
                  </c:pt>
                  <c:pt idx="1">
                    <c:v>0.15684390850044005</c:v>
                  </c:pt>
                  <c:pt idx="2">
                    <c:v>0.1621799857697086</c:v>
                  </c:pt>
                  <c:pt idx="3">
                    <c:v>0.20881193041690982</c:v>
                  </c:pt>
                  <c:pt idx="4">
                    <c:v>7.6134088398258082E-2</c:v>
                  </c:pt>
                  <c:pt idx="5">
                    <c:v>0.16606177642974518</c:v>
                  </c:pt>
                  <c:pt idx="6">
                    <c:v>0.20747347300788355</c:v>
                  </c:pt>
                  <c:pt idx="7">
                    <c:v>0.1975767969533524</c:v>
                  </c:pt>
                  <c:pt idx="8">
                    <c:v>4.3259429122954773E-2</c:v>
                  </c:pt>
                  <c:pt idx="9">
                    <c:v>0.26506776063611559</c:v>
                  </c:pt>
                  <c:pt idx="10">
                    <c:v>4.330572822783274E-2</c:v>
                  </c:pt>
                </c:numCache>
              </c:numRef>
            </c:plus>
            <c:minus>
              <c:numRef>
                <c:f>Sheet2!$D$18:$D$28</c:f>
                <c:numCache>
                  <c:formatCode>General</c:formatCode>
                  <c:ptCount val="11"/>
                  <c:pt idx="0">
                    <c:v>0.16448126826544907</c:v>
                  </c:pt>
                  <c:pt idx="1">
                    <c:v>0.14298453350696838</c:v>
                  </c:pt>
                  <c:pt idx="2">
                    <c:v>0.14311291699034112</c:v>
                  </c:pt>
                  <c:pt idx="3">
                    <c:v>0.18706768581888933</c:v>
                  </c:pt>
                  <c:pt idx="4">
                    <c:v>6.5837720245550291E-2</c:v>
                  </c:pt>
                  <c:pt idx="5">
                    <c:v>0.14154318577328262</c:v>
                  </c:pt>
                  <c:pt idx="6">
                    <c:v>0.18287178235996615</c:v>
                  </c:pt>
                  <c:pt idx="7">
                    <c:v>0.17018323761159371</c:v>
                  </c:pt>
                  <c:pt idx="8">
                    <c:v>3.9964928575463299E-2</c:v>
                  </c:pt>
                  <c:pt idx="9">
                    <c:v>0.23774836304073466</c:v>
                  </c:pt>
                  <c:pt idx="10">
                    <c:v>3.95355333614211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18:$A$21</c:f>
              <c:strCache>
                <c:ptCount val="4"/>
                <c:pt idx="0">
                  <c:v>Col-0</c:v>
                </c:pt>
                <c:pt idx="1">
                  <c:v>ProREF6-REF6-GFP-1</c:v>
                </c:pt>
                <c:pt idx="2">
                  <c:v>ProREF6-REF6-GFP-2</c:v>
                </c:pt>
                <c:pt idx="3">
                  <c:v>ProREF6-REF6-GFP-3</c:v>
                </c:pt>
              </c:strCache>
            </c:strRef>
          </c:cat>
          <c:val>
            <c:numRef>
              <c:f>Sheet2!$B$18:$B$21</c:f>
              <c:numCache>
                <c:formatCode>General</c:formatCode>
                <c:ptCount val="4"/>
                <c:pt idx="0">
                  <c:v>1</c:v>
                </c:pt>
                <c:pt idx="1">
                  <c:v>1.6181287468525052</c:v>
                </c:pt>
                <c:pt idx="2">
                  <c:v>1.217284686467933</c:v>
                </c:pt>
                <c:pt idx="3">
                  <c:v>1.7964277590044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671-462A-8CDD-9FA7902290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12319872"/>
        <c:axId val="1312326944"/>
      </c:barChart>
      <c:catAx>
        <c:axId val="1312319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zh-CN"/>
          </a:p>
        </c:txPr>
        <c:crossAx val="1312326944"/>
        <c:crosses val="autoZero"/>
        <c:auto val="1"/>
        <c:lblAlgn val="ctr"/>
        <c:lblOffset val="0"/>
        <c:noMultiLvlLbl val="0"/>
      </c:catAx>
      <c:valAx>
        <c:axId val="13123269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 sz="1400" dirty="0">
                    <a:latin typeface="Calibri Light" panose="020F0302020204030204" pitchFamily="34" charset="0"/>
                    <a:cs typeface="Calibri Light" panose="020F0302020204030204" pitchFamily="34" charset="0"/>
                  </a:rPr>
                  <a:t>Relative gene expression</a:t>
                </a:r>
                <a:endParaRPr lang="zh-CN" sz="1400" dirty="0">
                  <a:latin typeface="Calibri Light" panose="020F0302020204030204" pitchFamily="34" charset="0"/>
                  <a:cs typeface="Calibri Light" panose="020F0302020204030204" pitchFamily="34" charset="0"/>
                </a:endParaRPr>
              </a:p>
            </c:rich>
          </c:tx>
          <c:layout>
            <c:manualLayout>
              <c:xMode val="edge"/>
              <c:yMode val="edge"/>
              <c:x val="3.4178239664926974E-2"/>
              <c:y val="0.129440495544376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j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zh-CN"/>
          </a:p>
        </c:txPr>
        <c:crossAx val="1312319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ysClr val="windowText" lastClr="000000"/>
      </a:solidFill>
    </a:ln>
    <a:effectLst/>
  </c:spPr>
  <c:txPr>
    <a:bodyPr/>
    <a:lstStyle/>
    <a:p>
      <a:pPr>
        <a:defRPr>
          <a:latin typeface="+mj-lt"/>
        </a:defRPr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178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05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5950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9423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400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987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832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557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6924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99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824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484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57776" y="659961"/>
            <a:ext cx="8586453" cy="5648836"/>
            <a:chOff x="257776" y="795129"/>
            <a:chExt cx="8586453" cy="5648836"/>
          </a:xfrm>
        </p:grpSpPr>
        <p:sp>
          <p:nvSpPr>
            <p:cNvPr id="2" name="文本框 1"/>
            <p:cNvSpPr txBox="1"/>
            <p:nvPr/>
          </p:nvSpPr>
          <p:spPr>
            <a:xfrm>
              <a:off x="267942" y="5058970"/>
              <a:ext cx="8576287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ct val="150000"/>
                </a:lnSpc>
              </a:pP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.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ration and verification of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REF6-REF6-GFP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ansgenic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nes. (A) qRT-PCR analysis of the expression levels of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transgenic lines.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2A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 used as an internal control. </a:t>
              </a:r>
              <a:r>
                <a:rPr lang="en-US" altLang="zh-CN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s are shown as means ± </a:t>
              </a:r>
              <a:r>
                <a:rPr lang="en-US" altLang="zh-CN" sz="14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D.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Seed germination phenotype of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REF6-REF6-GFP-1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nder PHYB-on conditions.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 transgenic plants were generated in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-1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ackground. 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5" name="图表 4">
              <a:extLst>
                <a:ext uri="{FF2B5EF4-FFF2-40B4-BE49-F238E27FC236}">
                  <a16:creationId xmlns:lc="http://schemas.openxmlformats.org/drawingml/2006/lockedCanvas" xmlns:a16="http://schemas.microsoft.com/office/drawing/2014/main" xmlns:xdr="http://schemas.openxmlformats.org/drawingml/2006/spreadsheetDrawing" xmlns="" id="{04CF4B71-91C5-44E0-A6AC-58E1684CD14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32542426"/>
                </p:ext>
              </p:extLst>
            </p:nvPr>
          </p:nvGraphicFramePr>
          <p:xfrm>
            <a:off x="612246" y="923195"/>
            <a:ext cx="3866839" cy="38035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文本框 3"/>
            <p:cNvSpPr txBox="1"/>
            <p:nvPr/>
          </p:nvSpPr>
          <p:spPr>
            <a:xfrm>
              <a:off x="257776" y="795129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A</a:t>
              </a:r>
              <a:endParaRPr lang="zh-CN" altLang="en-US" sz="2000" dirty="0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4556086" y="795129"/>
              <a:ext cx="3337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 smtClean="0"/>
                <a:t>B</a:t>
              </a:r>
              <a:endParaRPr lang="zh-CN" altLang="en-US" sz="2000" dirty="0"/>
            </a:p>
          </p:txBody>
        </p:sp>
        <p:pic>
          <p:nvPicPr>
            <p:cNvPr id="7" name="图片 6">
              <a:extLst>
                <a:ext uri="{FF2B5EF4-FFF2-40B4-BE49-F238E27FC236}">
                  <a16:creationId xmlns="" xmlns:a16="http://schemas.microsoft.com/office/drawing/2014/main" id="{722C3CA3-FEB0-0416-29D5-E6C6ACC86E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21" t="36526" r="28633" b="7982"/>
            <a:stretch/>
          </p:blipFill>
          <p:spPr>
            <a:xfrm>
              <a:off x="4921568" y="923195"/>
              <a:ext cx="3807362" cy="3807361"/>
            </a:xfrm>
            <a:prstGeom prst="rect">
              <a:avLst/>
            </a:prstGeom>
          </p:spPr>
        </p:pic>
        <p:cxnSp>
          <p:nvCxnSpPr>
            <p:cNvPr id="8" name="直接连接符 7">
              <a:extLst>
                <a:ext uri="{FF2B5EF4-FFF2-40B4-BE49-F238E27FC236}">
                  <a16:creationId xmlns="" xmlns:a16="http://schemas.microsoft.com/office/drawing/2014/main" id="{7BEEF329-CA31-DD15-F165-DC4BC7EE2ABE}"/>
                </a:ext>
              </a:extLst>
            </p:cNvPr>
            <p:cNvCxnSpPr>
              <a:cxnSpLocks/>
            </p:cNvCxnSpPr>
            <p:nvPr/>
          </p:nvCxnSpPr>
          <p:spPr>
            <a:xfrm>
              <a:off x="5147762" y="2798632"/>
              <a:ext cx="3180829" cy="0"/>
            </a:xfrm>
            <a:prstGeom prst="line">
              <a:avLst/>
            </a:prstGeom>
            <a:ln w="19050">
              <a:solidFill>
                <a:schemeClr val="tx1">
                  <a:alpha val="2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直接连接符 8">
              <a:extLst>
                <a:ext uri="{FF2B5EF4-FFF2-40B4-BE49-F238E27FC236}">
                  <a16:creationId xmlns="" xmlns:a16="http://schemas.microsoft.com/office/drawing/2014/main" id="{CB6C9D51-94D6-2305-FF92-5A15551726F6}"/>
                </a:ext>
              </a:extLst>
            </p:cNvPr>
            <p:cNvCxnSpPr>
              <a:cxnSpLocks/>
            </p:cNvCxnSpPr>
            <p:nvPr/>
          </p:nvCxnSpPr>
          <p:spPr>
            <a:xfrm>
              <a:off x="6710874" y="1255450"/>
              <a:ext cx="27303" cy="3098069"/>
            </a:xfrm>
            <a:prstGeom prst="line">
              <a:avLst/>
            </a:prstGeom>
            <a:ln w="19050">
              <a:solidFill>
                <a:schemeClr val="tx1">
                  <a:lumMod val="85000"/>
                  <a:lumOff val="15000"/>
                  <a:alpha val="2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>
              <a:extLst>
                <a:ext uri="{FF2B5EF4-FFF2-40B4-BE49-F238E27FC236}">
                  <a16:creationId xmlns="" xmlns:a16="http://schemas.microsoft.com/office/drawing/2014/main" id="{3EA1FEAF-750B-4CCE-B4B1-0511D654C80C}"/>
                </a:ext>
              </a:extLst>
            </p:cNvPr>
            <p:cNvSpPr txBox="1"/>
            <p:nvPr/>
          </p:nvSpPr>
          <p:spPr>
            <a:xfrm>
              <a:off x="4960206" y="923195"/>
              <a:ext cx="6142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dirty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Col-0</a:t>
              </a:r>
              <a:endParaRPr lang="zh-CN" altLang="en-US" sz="1600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="" xmlns:a16="http://schemas.microsoft.com/office/drawing/2014/main" id="{7751B926-5565-4B98-E7A1-9FE48B7E8A95}"/>
                </a:ext>
              </a:extLst>
            </p:cNvPr>
            <p:cNvSpPr txBox="1"/>
            <p:nvPr/>
          </p:nvSpPr>
          <p:spPr>
            <a:xfrm>
              <a:off x="7284023" y="923195"/>
              <a:ext cx="144490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i="1" dirty="0" smtClean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ProREF6-REF6-GFP-1</a:t>
              </a:r>
              <a:endParaRPr lang="zh-CN" altLang="en-US" sz="1600" i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="" xmlns:a16="http://schemas.microsoft.com/office/drawing/2014/main" id="{A0C0A1FE-6575-E9C6-7983-8F16BC2E8620}"/>
                </a:ext>
              </a:extLst>
            </p:cNvPr>
            <p:cNvSpPr txBox="1"/>
            <p:nvPr/>
          </p:nvSpPr>
          <p:spPr>
            <a:xfrm>
              <a:off x="4974057" y="4388160"/>
              <a:ext cx="6803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i="1" dirty="0" smtClean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ref6-1</a:t>
              </a:r>
              <a:endParaRPr lang="zh-CN" altLang="en-US" sz="1600" i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="" xmlns:a16="http://schemas.microsoft.com/office/drawing/2014/main" id="{7751B926-5565-4B98-E7A1-9FE48B7E8A95}"/>
                </a:ext>
              </a:extLst>
            </p:cNvPr>
            <p:cNvSpPr txBox="1"/>
            <p:nvPr/>
          </p:nvSpPr>
          <p:spPr>
            <a:xfrm>
              <a:off x="7315759" y="4201911"/>
              <a:ext cx="144490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i="1" dirty="0" smtClean="0">
                  <a:solidFill>
                    <a:schemeClr val="bg1"/>
                  </a:solidFill>
                  <a:latin typeface="Calibri Light" panose="020F0302020204030204" pitchFamily="34" charset="0"/>
                  <a:cs typeface="Calibri Light" panose="020F0302020204030204" pitchFamily="34" charset="0"/>
                </a:rPr>
                <a:t>ProREF6-REF6-GFP-2</a:t>
              </a:r>
              <a:endParaRPr lang="zh-CN" altLang="en-US" sz="1600" i="1" dirty="0">
                <a:solidFill>
                  <a:schemeClr val="bg1"/>
                </a:solidFill>
                <a:latin typeface="Calibri Light" panose="020F0302020204030204" pitchFamily="34" charset="0"/>
                <a:cs typeface="Calibri Light" panose="020F03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02897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0</TotalTime>
  <Words>77</Words>
  <Application>Microsoft Office PowerPoint</Application>
  <PresentationFormat>全屏显示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21</cp:revision>
  <dcterms:created xsi:type="dcterms:W3CDTF">2022-11-05T14:28:04Z</dcterms:created>
  <dcterms:modified xsi:type="dcterms:W3CDTF">2022-12-15T09:13:32Z</dcterms:modified>
</cp:coreProperties>
</file>